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EF13C3-CCC6-4051-94F4-74E200180BF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CD5CAF-1867-4214-BD28-6B2FE92C59D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3330D0-A1F4-46CD-B81A-F5871996AFD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36C840-4AF7-4C8C-87EF-3101B33DD0F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43E9E1-4C65-4EAF-813F-094AEBB3F42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D9B03D-21C8-4B52-A12A-CA933988FF7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C70EAC-AB20-4E65-B449-3C5323B020E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51EC6A-AC47-4C64-9FC4-6B7599470E5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E87987-3AD8-41C7-945A-CEAB047800D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1F9247-2180-40A7-9ED8-CBBE3E966C1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E5424A-1511-4B38-8B74-5826DA2D025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BC15C8-1199-4A32-B27B-0DAC5500172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65717D3-1C60-430A-9385-678ACD3D99E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2149560" y="4946760"/>
            <a:ext cx="69840" cy="69840"/>
            <a:chOff x="2149560" y="4946760"/>
            <a:chExt cx="69840" cy="69840"/>
          </a:xfrm>
        </p:grpSpPr>
        <p:sp>
          <p:nvSpPr>
            <p:cNvPr id="42" name=""/>
            <p:cNvSpPr/>
            <p:nvPr/>
          </p:nvSpPr>
          <p:spPr>
            <a:xfrm>
              <a:off x="2180520" y="4946760"/>
              <a:ext cx="0" cy="69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2149560" y="4946760"/>
              <a:ext cx="6984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4" name=""/>
          <p:cNvGrpSpPr/>
          <p:nvPr/>
        </p:nvGrpSpPr>
        <p:grpSpPr>
          <a:xfrm>
            <a:off x="1930320" y="5005440"/>
            <a:ext cx="69840" cy="69840"/>
            <a:chOff x="1930320" y="5005440"/>
            <a:chExt cx="69840" cy="69840"/>
          </a:xfrm>
        </p:grpSpPr>
        <p:sp>
          <p:nvSpPr>
            <p:cNvPr id="45" name=""/>
            <p:cNvSpPr/>
            <p:nvPr/>
          </p:nvSpPr>
          <p:spPr>
            <a:xfrm>
              <a:off x="1961280" y="5005440"/>
              <a:ext cx="0" cy="69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1930320" y="5005440"/>
              <a:ext cx="6984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7" name=""/>
          <p:cNvGrpSpPr/>
          <p:nvPr/>
        </p:nvGrpSpPr>
        <p:grpSpPr>
          <a:xfrm>
            <a:off x="3838680" y="4836960"/>
            <a:ext cx="69840" cy="69840"/>
            <a:chOff x="3838680" y="4836960"/>
            <a:chExt cx="69840" cy="69840"/>
          </a:xfrm>
        </p:grpSpPr>
        <p:sp>
          <p:nvSpPr>
            <p:cNvPr id="48" name=""/>
            <p:cNvSpPr/>
            <p:nvPr/>
          </p:nvSpPr>
          <p:spPr>
            <a:xfrm>
              <a:off x="3869640" y="4836960"/>
              <a:ext cx="0" cy="69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3838680" y="4836960"/>
              <a:ext cx="6984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0" name=""/>
          <p:cNvGrpSpPr/>
          <p:nvPr/>
        </p:nvGrpSpPr>
        <p:grpSpPr>
          <a:xfrm>
            <a:off x="3633840" y="4921200"/>
            <a:ext cx="69840" cy="69840"/>
            <a:chOff x="3633840" y="4921200"/>
            <a:chExt cx="69840" cy="69840"/>
          </a:xfrm>
        </p:grpSpPr>
        <p:sp>
          <p:nvSpPr>
            <p:cNvPr id="51" name=""/>
            <p:cNvSpPr/>
            <p:nvPr/>
          </p:nvSpPr>
          <p:spPr>
            <a:xfrm>
              <a:off x="3664800" y="4921200"/>
              <a:ext cx="0" cy="69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3633840" y="4921200"/>
              <a:ext cx="6984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3" name=""/>
          <p:cNvGrpSpPr/>
          <p:nvPr/>
        </p:nvGrpSpPr>
        <p:grpSpPr>
          <a:xfrm>
            <a:off x="2725560" y="4944960"/>
            <a:ext cx="70200" cy="69840"/>
            <a:chOff x="2725560" y="4944960"/>
            <a:chExt cx="70200" cy="69840"/>
          </a:xfrm>
        </p:grpSpPr>
        <p:sp>
          <p:nvSpPr>
            <p:cNvPr id="54" name=""/>
            <p:cNvSpPr/>
            <p:nvPr/>
          </p:nvSpPr>
          <p:spPr>
            <a:xfrm>
              <a:off x="2756520" y="4944960"/>
              <a:ext cx="0" cy="69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2725560" y="4944960"/>
              <a:ext cx="7020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6" name=""/>
          <p:cNvGrpSpPr/>
          <p:nvPr/>
        </p:nvGrpSpPr>
        <p:grpSpPr>
          <a:xfrm>
            <a:off x="2928960" y="4930920"/>
            <a:ext cx="69840" cy="69840"/>
            <a:chOff x="2928960" y="4930920"/>
            <a:chExt cx="69840" cy="69840"/>
          </a:xfrm>
        </p:grpSpPr>
        <p:sp>
          <p:nvSpPr>
            <p:cNvPr id="57" name=""/>
            <p:cNvSpPr/>
            <p:nvPr/>
          </p:nvSpPr>
          <p:spPr>
            <a:xfrm>
              <a:off x="2959920" y="4930920"/>
              <a:ext cx="0" cy="69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2928960" y="4930920"/>
              <a:ext cx="6984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9" name=""/>
          <p:cNvGrpSpPr/>
          <p:nvPr/>
        </p:nvGrpSpPr>
        <p:grpSpPr>
          <a:xfrm>
            <a:off x="3146400" y="4965840"/>
            <a:ext cx="69840" cy="69840"/>
            <a:chOff x="3146400" y="4965840"/>
            <a:chExt cx="69840" cy="69840"/>
          </a:xfrm>
        </p:grpSpPr>
        <p:sp>
          <p:nvSpPr>
            <p:cNvPr id="60" name=""/>
            <p:cNvSpPr/>
            <p:nvPr/>
          </p:nvSpPr>
          <p:spPr>
            <a:xfrm>
              <a:off x="3177360" y="4965840"/>
              <a:ext cx="0" cy="69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3146400" y="4965840"/>
              <a:ext cx="6984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2" name=""/>
          <p:cNvSpPr/>
          <p:nvPr/>
        </p:nvSpPr>
        <p:spPr>
          <a:xfrm>
            <a:off x="1695600" y="5230800"/>
            <a:ext cx="145800" cy="85680"/>
          </a:xfrm>
          <a:prstGeom prst="rect">
            <a:avLst/>
          </a:prstGeom>
          <a:gradFill rotWithShape="0">
            <a:gsLst>
              <a:gs pos="0">
                <a:srgbClr val="000000"/>
              </a:gs>
              <a:gs pos="100000">
                <a:srgbClr val="ffffff"/>
              </a:gs>
            </a:gsLst>
            <a:lin ang="135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1892160" y="5014800"/>
            <a:ext cx="146160" cy="301680"/>
          </a:xfrm>
          <a:prstGeom prst="rect">
            <a:avLst/>
          </a:prstGeom>
          <a:gradFill rotWithShape="0">
            <a:gsLst>
              <a:gs pos="0">
                <a:srgbClr val="000000"/>
              </a:gs>
              <a:gs pos="100000">
                <a:srgbClr val="ffffff"/>
              </a:gs>
            </a:gsLst>
            <a:lin ang="135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2109960" y="4959360"/>
            <a:ext cx="145800" cy="357120"/>
          </a:xfrm>
          <a:prstGeom prst="rect">
            <a:avLst/>
          </a:prstGeom>
          <a:gradFill rotWithShape="0">
            <a:gsLst>
              <a:gs pos="0">
                <a:srgbClr val="000000"/>
              </a:gs>
              <a:gs pos="100000">
                <a:srgbClr val="ffffff"/>
              </a:gs>
            </a:gsLst>
            <a:lin ang="135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2695680" y="4959360"/>
            <a:ext cx="144360" cy="357120"/>
          </a:xfrm>
          <a:prstGeom prst="rect">
            <a:avLst/>
          </a:prstGeom>
          <a:gradFill rotWithShape="0">
            <a:gsLst>
              <a:gs pos="0">
                <a:srgbClr val="000000"/>
              </a:gs>
              <a:gs pos="100000">
                <a:srgbClr val="ffffff"/>
              </a:gs>
            </a:gsLst>
            <a:lin ang="135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2892600" y="4950000"/>
            <a:ext cx="145800" cy="366480"/>
          </a:xfrm>
          <a:prstGeom prst="rect">
            <a:avLst/>
          </a:prstGeom>
          <a:gradFill rotWithShape="0">
            <a:gsLst>
              <a:gs pos="0">
                <a:srgbClr val="000000"/>
              </a:gs>
              <a:gs pos="100000">
                <a:srgbClr val="ffffff"/>
              </a:gs>
            </a:gsLst>
            <a:lin ang="135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3100320" y="4978440"/>
            <a:ext cx="146160" cy="338040"/>
          </a:xfrm>
          <a:prstGeom prst="rect">
            <a:avLst/>
          </a:prstGeom>
          <a:gradFill rotWithShape="0">
            <a:gsLst>
              <a:gs pos="0">
                <a:srgbClr val="000000"/>
              </a:gs>
              <a:gs pos="100000">
                <a:srgbClr val="ffffff"/>
              </a:gs>
            </a:gsLst>
            <a:lin ang="135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3595680" y="4940280"/>
            <a:ext cx="144360" cy="376200"/>
          </a:xfrm>
          <a:prstGeom prst="rect">
            <a:avLst/>
          </a:prstGeom>
          <a:gradFill rotWithShape="0">
            <a:gsLst>
              <a:gs pos="0">
                <a:srgbClr val="000000"/>
              </a:gs>
              <a:gs pos="100000">
                <a:srgbClr val="ffffff"/>
              </a:gs>
            </a:gsLst>
            <a:lin ang="135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3797280" y="4856040"/>
            <a:ext cx="146160" cy="460440"/>
          </a:xfrm>
          <a:prstGeom prst="rect">
            <a:avLst/>
          </a:prstGeom>
          <a:gradFill rotWithShape="0">
            <a:gsLst>
              <a:gs pos="0">
                <a:srgbClr val="000000"/>
              </a:gs>
              <a:gs pos="100000">
                <a:srgbClr val="ffffff"/>
              </a:gs>
            </a:gsLst>
            <a:lin ang="135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1531800" y="4089240"/>
            <a:ext cx="1800" cy="12319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1498680" y="4902120"/>
            <a:ext cx="381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1498680" y="4497480"/>
            <a:ext cx="381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1495440" y="4087800"/>
            <a:ext cx="381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1500120" y="5321160"/>
            <a:ext cx="29577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1394640" y="517860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1386720" y="476568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1319400" y="436104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1322640" y="395136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805320" y="5402160"/>
            <a:ext cx="529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Arial"/>
              </a:rPr>
              <a:t>day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410760" y="5680080"/>
            <a:ext cx="1220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Arial"/>
              </a:rPr>
              <a:t>SB216763(</a:t>
            </a:r>
            <a:r>
              <a:rPr b="1" lang="it-IT" sz="12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1" lang="it-IT" sz="1200" spc="-1" strike="noStrike">
                <a:solidFill>
                  <a:srgbClr val="000000"/>
                </a:solidFill>
                <a:latin typeface="Arial"/>
              </a:rPr>
              <a:t>M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1968120" y="5400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2907720" y="539748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3793680" y="539748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1622160" y="501336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1771200" y="477036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3.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2009520" y="467820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4.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2577960" y="471816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4.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2784240" y="463716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4.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2995200" y="473868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4.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3492360" y="470376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4.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3704760" y="461016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5.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 rot="16200000">
            <a:off x="244800" y="4474440"/>
            <a:ext cx="14580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Arial"/>
              </a:rPr>
              <a:t>Slug mRNA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Arial"/>
              </a:rPr>
              <a:t>expression leve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4294440" y="6345360"/>
            <a:ext cx="4917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S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1754280" y="4599000"/>
            <a:ext cx="0" cy="4316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1755720" y="4597560"/>
            <a:ext cx="4111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1954080" y="4599000"/>
            <a:ext cx="0" cy="1080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2171880" y="4595760"/>
            <a:ext cx="0" cy="1080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1721160" y="4390920"/>
            <a:ext cx="25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1945080" y="4390920"/>
            <a:ext cx="25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3281400" y="5300640"/>
            <a:ext cx="146160" cy="14400"/>
          </a:xfrm>
          <a:prstGeom prst="rect">
            <a:avLst/>
          </a:prstGeom>
          <a:gradFill rotWithShape="0">
            <a:gsLst>
              <a:gs pos="0">
                <a:srgbClr val="000000"/>
              </a:gs>
              <a:gs pos="100000">
                <a:srgbClr val="ffffff"/>
              </a:gs>
            </a:gsLst>
            <a:lin ang="135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2400" bIns="-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2330280" y="5303880"/>
            <a:ext cx="146160" cy="14400"/>
          </a:xfrm>
          <a:prstGeom prst="rect">
            <a:avLst/>
          </a:prstGeom>
          <a:gradFill rotWithShape="0">
            <a:gsLst>
              <a:gs pos="0">
                <a:srgbClr val="000000"/>
              </a:gs>
              <a:gs pos="100000">
                <a:srgbClr val="ffffff"/>
              </a:gs>
            </a:gsLst>
            <a:lin ang="135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2400" bIns="-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3978360" y="5303880"/>
            <a:ext cx="145800" cy="14400"/>
          </a:xfrm>
          <a:prstGeom prst="rect">
            <a:avLst/>
          </a:prstGeom>
          <a:gradFill rotWithShape="0">
            <a:gsLst>
              <a:gs pos="0">
                <a:srgbClr val="000000"/>
              </a:gs>
              <a:gs pos="100000">
                <a:srgbClr val="ffffff"/>
              </a:gs>
            </a:gsLst>
            <a:lin ang="135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2400" bIns="-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4178160" y="5303880"/>
            <a:ext cx="146160" cy="14400"/>
          </a:xfrm>
          <a:prstGeom prst="rect">
            <a:avLst/>
          </a:prstGeom>
          <a:gradFill rotWithShape="0">
            <a:gsLst>
              <a:gs pos="0">
                <a:srgbClr val="000000"/>
              </a:gs>
              <a:gs pos="100000">
                <a:srgbClr val="ffffff"/>
              </a:gs>
            </a:gsLst>
            <a:lin ang="135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2400" bIns="-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2848320" y="3753000"/>
            <a:ext cx="4838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CAL7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5" name=""/>
          <p:cNvGrpSpPr/>
          <p:nvPr/>
        </p:nvGrpSpPr>
        <p:grpSpPr>
          <a:xfrm>
            <a:off x="1520280" y="5688000"/>
            <a:ext cx="1154160" cy="276480"/>
            <a:chOff x="1520280" y="5688000"/>
            <a:chExt cx="1154160" cy="276480"/>
          </a:xfrm>
        </p:grpSpPr>
        <p:sp>
          <p:nvSpPr>
            <p:cNvPr id="106" name=""/>
            <p:cNvSpPr/>
            <p:nvPr/>
          </p:nvSpPr>
          <p:spPr>
            <a:xfrm>
              <a:off x="1520280" y="5688000"/>
              <a:ext cx="615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  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-  1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2004840" y="5688000"/>
              <a:ext cx="451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2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2222280" y="5688000"/>
              <a:ext cx="452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9" name=""/>
          <p:cNvGrpSpPr/>
          <p:nvPr/>
        </p:nvGrpSpPr>
        <p:grpSpPr>
          <a:xfrm>
            <a:off x="2512440" y="5692680"/>
            <a:ext cx="1154160" cy="276480"/>
            <a:chOff x="2512440" y="5692680"/>
            <a:chExt cx="1154160" cy="276480"/>
          </a:xfrm>
        </p:grpSpPr>
        <p:sp>
          <p:nvSpPr>
            <p:cNvPr id="110" name=""/>
            <p:cNvSpPr/>
            <p:nvPr/>
          </p:nvSpPr>
          <p:spPr>
            <a:xfrm>
              <a:off x="2512440" y="5692680"/>
              <a:ext cx="615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  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-  1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2997000" y="5692680"/>
              <a:ext cx="451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2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3214440" y="5692680"/>
              <a:ext cx="452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3" name=""/>
          <p:cNvGrpSpPr/>
          <p:nvPr/>
        </p:nvGrpSpPr>
        <p:grpSpPr>
          <a:xfrm>
            <a:off x="3412440" y="5692680"/>
            <a:ext cx="1154880" cy="276480"/>
            <a:chOff x="3412440" y="5692680"/>
            <a:chExt cx="1154880" cy="276480"/>
          </a:xfrm>
        </p:grpSpPr>
        <p:sp>
          <p:nvSpPr>
            <p:cNvPr id="114" name=""/>
            <p:cNvSpPr/>
            <p:nvPr/>
          </p:nvSpPr>
          <p:spPr>
            <a:xfrm>
              <a:off x="3412440" y="5692680"/>
              <a:ext cx="615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  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-  1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3897360" y="5692680"/>
              <a:ext cx="452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2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4114800" y="5692680"/>
              <a:ext cx="452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7" name=""/>
          <p:cNvGrpSpPr/>
          <p:nvPr/>
        </p:nvGrpSpPr>
        <p:grpSpPr>
          <a:xfrm>
            <a:off x="2174760" y="944640"/>
            <a:ext cx="69840" cy="19080"/>
            <a:chOff x="2174760" y="944640"/>
            <a:chExt cx="69840" cy="19080"/>
          </a:xfrm>
        </p:grpSpPr>
        <p:sp>
          <p:nvSpPr>
            <p:cNvPr id="118" name=""/>
            <p:cNvSpPr/>
            <p:nvPr/>
          </p:nvSpPr>
          <p:spPr>
            <a:xfrm>
              <a:off x="2205720" y="944640"/>
              <a:ext cx="0" cy="19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2174760" y="944640"/>
              <a:ext cx="6984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0" name=""/>
          <p:cNvGrpSpPr/>
          <p:nvPr/>
        </p:nvGrpSpPr>
        <p:grpSpPr>
          <a:xfrm>
            <a:off x="1968480" y="936720"/>
            <a:ext cx="69840" cy="19080"/>
            <a:chOff x="1968480" y="936720"/>
            <a:chExt cx="69840" cy="19080"/>
          </a:xfrm>
        </p:grpSpPr>
        <p:sp>
          <p:nvSpPr>
            <p:cNvPr id="121" name=""/>
            <p:cNvSpPr/>
            <p:nvPr/>
          </p:nvSpPr>
          <p:spPr>
            <a:xfrm>
              <a:off x="1999440" y="936720"/>
              <a:ext cx="0" cy="19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1968480" y="936720"/>
              <a:ext cx="6984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3" name=""/>
          <p:cNvGrpSpPr/>
          <p:nvPr/>
        </p:nvGrpSpPr>
        <p:grpSpPr>
          <a:xfrm>
            <a:off x="1754280" y="2523960"/>
            <a:ext cx="69840" cy="19080"/>
            <a:chOff x="1754280" y="2523960"/>
            <a:chExt cx="69840" cy="19080"/>
          </a:xfrm>
        </p:grpSpPr>
        <p:sp>
          <p:nvSpPr>
            <p:cNvPr id="124" name=""/>
            <p:cNvSpPr/>
            <p:nvPr/>
          </p:nvSpPr>
          <p:spPr>
            <a:xfrm>
              <a:off x="1785240" y="2523960"/>
              <a:ext cx="0" cy="19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1754280" y="2523960"/>
              <a:ext cx="6984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6" name=""/>
          <p:cNvGrpSpPr/>
          <p:nvPr/>
        </p:nvGrpSpPr>
        <p:grpSpPr>
          <a:xfrm>
            <a:off x="2390760" y="1724040"/>
            <a:ext cx="69840" cy="19080"/>
            <a:chOff x="2390760" y="1724040"/>
            <a:chExt cx="69840" cy="19080"/>
          </a:xfrm>
        </p:grpSpPr>
        <p:sp>
          <p:nvSpPr>
            <p:cNvPr id="127" name=""/>
            <p:cNvSpPr/>
            <p:nvPr/>
          </p:nvSpPr>
          <p:spPr>
            <a:xfrm>
              <a:off x="2421720" y="1724040"/>
              <a:ext cx="0" cy="19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2390760" y="1724040"/>
              <a:ext cx="6984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9" name=""/>
          <p:cNvGrpSpPr/>
          <p:nvPr/>
        </p:nvGrpSpPr>
        <p:grpSpPr>
          <a:xfrm>
            <a:off x="3652920" y="2603520"/>
            <a:ext cx="69840" cy="9360"/>
            <a:chOff x="3652920" y="2603520"/>
            <a:chExt cx="69840" cy="9360"/>
          </a:xfrm>
        </p:grpSpPr>
        <p:sp>
          <p:nvSpPr>
            <p:cNvPr id="130" name=""/>
            <p:cNvSpPr/>
            <p:nvPr/>
          </p:nvSpPr>
          <p:spPr>
            <a:xfrm>
              <a:off x="3683880" y="2603520"/>
              <a:ext cx="0" cy="93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3652920" y="2603520"/>
              <a:ext cx="6984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32" name=""/>
          <p:cNvGrpSpPr/>
          <p:nvPr/>
        </p:nvGrpSpPr>
        <p:grpSpPr>
          <a:xfrm>
            <a:off x="4041720" y="2384280"/>
            <a:ext cx="69840" cy="9720"/>
            <a:chOff x="4041720" y="2384280"/>
            <a:chExt cx="69840" cy="9720"/>
          </a:xfrm>
        </p:grpSpPr>
        <p:sp>
          <p:nvSpPr>
            <p:cNvPr id="133" name=""/>
            <p:cNvSpPr/>
            <p:nvPr/>
          </p:nvSpPr>
          <p:spPr>
            <a:xfrm>
              <a:off x="4072680" y="2384280"/>
              <a:ext cx="0" cy="97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4041720" y="2384280"/>
              <a:ext cx="6984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35" name=""/>
          <p:cNvGrpSpPr/>
          <p:nvPr/>
        </p:nvGrpSpPr>
        <p:grpSpPr>
          <a:xfrm>
            <a:off x="4251240" y="2612880"/>
            <a:ext cx="69840" cy="9720"/>
            <a:chOff x="4251240" y="2612880"/>
            <a:chExt cx="69840" cy="9720"/>
          </a:xfrm>
        </p:grpSpPr>
        <p:sp>
          <p:nvSpPr>
            <p:cNvPr id="136" name=""/>
            <p:cNvSpPr/>
            <p:nvPr/>
          </p:nvSpPr>
          <p:spPr>
            <a:xfrm>
              <a:off x="4282200" y="2612880"/>
              <a:ext cx="0" cy="97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>
              <a:off x="4251240" y="2612880"/>
              <a:ext cx="6984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38" name=""/>
          <p:cNvGrpSpPr/>
          <p:nvPr/>
        </p:nvGrpSpPr>
        <p:grpSpPr>
          <a:xfrm>
            <a:off x="2928960" y="2365200"/>
            <a:ext cx="69840" cy="9720"/>
            <a:chOff x="2928960" y="2365200"/>
            <a:chExt cx="69840" cy="9720"/>
          </a:xfrm>
        </p:grpSpPr>
        <p:sp>
          <p:nvSpPr>
            <p:cNvPr id="139" name=""/>
            <p:cNvSpPr/>
            <p:nvPr/>
          </p:nvSpPr>
          <p:spPr>
            <a:xfrm>
              <a:off x="2959920" y="2365200"/>
              <a:ext cx="0" cy="97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2928960" y="2365200"/>
              <a:ext cx="6984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41" name=""/>
          <p:cNvGrpSpPr/>
          <p:nvPr/>
        </p:nvGrpSpPr>
        <p:grpSpPr>
          <a:xfrm>
            <a:off x="3119400" y="2475000"/>
            <a:ext cx="69840" cy="9360"/>
            <a:chOff x="3119400" y="2475000"/>
            <a:chExt cx="69840" cy="9360"/>
          </a:xfrm>
        </p:grpSpPr>
        <p:sp>
          <p:nvSpPr>
            <p:cNvPr id="142" name=""/>
            <p:cNvSpPr/>
            <p:nvPr/>
          </p:nvSpPr>
          <p:spPr>
            <a:xfrm>
              <a:off x="3150360" y="2475000"/>
              <a:ext cx="0" cy="93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>
              <a:off x="3119400" y="2475000"/>
              <a:ext cx="6984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44" name=""/>
          <p:cNvGrpSpPr/>
          <p:nvPr/>
        </p:nvGrpSpPr>
        <p:grpSpPr>
          <a:xfrm>
            <a:off x="2719440" y="2475000"/>
            <a:ext cx="69840" cy="9360"/>
            <a:chOff x="2719440" y="2475000"/>
            <a:chExt cx="69840" cy="9360"/>
          </a:xfrm>
        </p:grpSpPr>
        <p:sp>
          <p:nvSpPr>
            <p:cNvPr id="145" name=""/>
            <p:cNvSpPr/>
            <p:nvPr/>
          </p:nvSpPr>
          <p:spPr>
            <a:xfrm>
              <a:off x="2750400" y="2475000"/>
              <a:ext cx="0" cy="93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>
              <a:off x="2719440" y="2475000"/>
              <a:ext cx="6984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47" name=""/>
          <p:cNvSpPr/>
          <p:nvPr/>
        </p:nvSpPr>
        <p:spPr>
          <a:xfrm>
            <a:off x="1924200" y="955800"/>
            <a:ext cx="155520" cy="1785960"/>
          </a:xfrm>
          <a:prstGeom prst="rect">
            <a:avLst/>
          </a:prstGeom>
          <a:gradFill rotWithShape="0">
            <a:gsLst>
              <a:gs pos="0">
                <a:srgbClr val="818181"/>
              </a:gs>
              <a:gs pos="100000">
                <a:srgbClr val="b2b2b2">
                  <a:alpha val="49019"/>
                </a:srgbClr>
              </a:gs>
            </a:gsLst>
            <a:lin ang="135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>
            <a:off x="2349360" y="1743120"/>
            <a:ext cx="154080" cy="996840"/>
          </a:xfrm>
          <a:prstGeom prst="rect">
            <a:avLst/>
          </a:prstGeom>
          <a:gradFill rotWithShape="0">
            <a:gsLst>
              <a:gs pos="0">
                <a:srgbClr val="818181"/>
              </a:gs>
              <a:gs pos="100000">
                <a:srgbClr val="b2b2b2">
                  <a:alpha val="49019"/>
                </a:srgbClr>
              </a:gs>
            </a:gsLst>
            <a:lin ang="135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2678040" y="2489040"/>
            <a:ext cx="154080" cy="249480"/>
          </a:xfrm>
          <a:prstGeom prst="rect">
            <a:avLst/>
          </a:prstGeom>
          <a:gradFill rotWithShape="0">
            <a:gsLst>
              <a:gs pos="0">
                <a:srgbClr val="818181"/>
              </a:gs>
              <a:gs pos="100000">
                <a:srgbClr val="b2b2b2">
                  <a:alpha val="49019"/>
                </a:srgbClr>
              </a:gs>
            </a:gsLst>
            <a:lin ang="135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>
            <a:off x="2887560" y="2381400"/>
            <a:ext cx="155520" cy="357120"/>
          </a:xfrm>
          <a:prstGeom prst="rect">
            <a:avLst/>
          </a:prstGeom>
          <a:gradFill rotWithShape="0">
            <a:gsLst>
              <a:gs pos="0">
                <a:srgbClr val="818181"/>
              </a:gs>
              <a:gs pos="100000">
                <a:srgbClr val="b2b2b2">
                  <a:alpha val="49019"/>
                </a:srgbClr>
              </a:gs>
            </a:gsLst>
            <a:lin ang="135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>
            <a:off x="3073320" y="2489040"/>
            <a:ext cx="155520" cy="249480"/>
          </a:xfrm>
          <a:prstGeom prst="rect">
            <a:avLst/>
          </a:prstGeom>
          <a:gradFill rotWithShape="0">
            <a:gsLst>
              <a:gs pos="0">
                <a:srgbClr val="818181"/>
              </a:gs>
              <a:gs pos="100000">
                <a:srgbClr val="b2b2b2">
                  <a:alpha val="49019"/>
                </a:srgbClr>
              </a:gs>
            </a:gsLst>
            <a:lin ang="135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>
            <a:off x="3278160" y="2441520"/>
            <a:ext cx="154080" cy="298440"/>
          </a:xfrm>
          <a:prstGeom prst="rect">
            <a:avLst/>
          </a:prstGeom>
          <a:gradFill rotWithShape="0">
            <a:gsLst>
              <a:gs pos="0">
                <a:srgbClr val="818181"/>
              </a:gs>
              <a:gs pos="100000">
                <a:srgbClr val="b2b2b2">
                  <a:alpha val="49019"/>
                </a:srgbClr>
              </a:gs>
            </a:gsLst>
            <a:lin ang="135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>
            <a:off x="3613320" y="2616120"/>
            <a:ext cx="153720" cy="123840"/>
          </a:xfrm>
          <a:prstGeom prst="rect">
            <a:avLst/>
          </a:prstGeom>
          <a:gradFill rotWithShape="0">
            <a:gsLst>
              <a:gs pos="0">
                <a:srgbClr val="818181"/>
              </a:gs>
              <a:gs pos="100000">
                <a:srgbClr val="b2b2b2">
                  <a:alpha val="49019"/>
                </a:srgbClr>
              </a:gs>
            </a:gsLst>
            <a:lin ang="135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>
            <a:off x="3805200" y="2657520"/>
            <a:ext cx="154080" cy="82440"/>
          </a:xfrm>
          <a:prstGeom prst="rect">
            <a:avLst/>
          </a:prstGeom>
          <a:gradFill rotWithShape="0">
            <a:gsLst>
              <a:gs pos="0">
                <a:srgbClr val="656565"/>
              </a:gs>
              <a:gs pos="100000">
                <a:srgbClr val="b2b2b2">
                  <a:alpha val="49019"/>
                </a:srgbClr>
              </a:gs>
            </a:gsLst>
            <a:lin ang="135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5640" bIns="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4000680" y="2400480"/>
            <a:ext cx="155520" cy="339480"/>
          </a:xfrm>
          <a:prstGeom prst="rect">
            <a:avLst/>
          </a:prstGeom>
          <a:gradFill rotWithShape="0">
            <a:gsLst>
              <a:gs pos="0">
                <a:srgbClr val="545454"/>
              </a:gs>
              <a:gs pos="100000">
                <a:srgbClr val="b2b2b2">
                  <a:alpha val="49019"/>
                </a:srgbClr>
              </a:gs>
            </a:gsLst>
            <a:lin ang="135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>
            <a:off x="4205160" y="2624040"/>
            <a:ext cx="155880" cy="115920"/>
          </a:xfrm>
          <a:prstGeom prst="rect">
            <a:avLst/>
          </a:prstGeom>
          <a:gradFill rotWithShape="0">
            <a:gsLst>
              <a:gs pos="0">
                <a:srgbClr val="818181"/>
              </a:gs>
              <a:gs pos="100000">
                <a:srgbClr val="b2b2b2">
                  <a:alpha val="49019"/>
                </a:srgbClr>
              </a:gs>
            </a:gsLst>
            <a:lin ang="135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 flipV="1">
            <a:off x="1482840" y="2738520"/>
            <a:ext cx="2955960" cy="9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>
            <a:off x="2781360" y="217440"/>
            <a:ext cx="544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SaOS-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>
            <a:off x="757440" y="2817720"/>
            <a:ext cx="529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Arial"/>
              </a:rPr>
              <a:t>day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378720" y="3186000"/>
            <a:ext cx="1220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Arial"/>
              </a:rPr>
              <a:t>SB216763(</a:t>
            </a:r>
            <a:r>
              <a:rPr b="1" lang="it-IT" sz="12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1" lang="it-IT" sz="1200" spc="-1" strike="noStrike">
                <a:solidFill>
                  <a:srgbClr val="000000"/>
                </a:solidFill>
                <a:latin typeface="Arial"/>
              </a:rPr>
              <a:t>M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>
            <a:off x="1979280" y="2817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>
            <a:off x="2964960" y="281628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>
            <a:off x="3812760" y="281628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>
            <a:off x="1545120" y="3198960"/>
            <a:ext cx="1041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  10 25 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>
            <a:off x="3437640" y="3195720"/>
            <a:ext cx="1041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  10 25 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 rot="16200000">
            <a:off x="109440" y="1365840"/>
            <a:ext cx="15008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Arial"/>
              </a:rPr>
              <a:t>Slug mRN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it-IT" sz="1200" spc="-1" strike="noStrike">
                <a:solidFill>
                  <a:srgbClr val="000000"/>
                </a:solidFill>
                <a:latin typeface="Arial"/>
              </a:rPr>
              <a:t>expression leve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 flipV="1">
            <a:off x="1886040" y="1321920"/>
            <a:ext cx="230040" cy="1256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>
            <a:off x="1511280" y="660240"/>
            <a:ext cx="1440" cy="20941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>
            <a:off x="1471680" y="2330280"/>
            <a:ext cx="4104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>
            <a:off x="1471680" y="1914480"/>
            <a:ext cx="4104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>
            <a:off x="1471680" y="1498680"/>
            <a:ext cx="410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"/>
          <p:cNvSpPr/>
          <p:nvPr/>
        </p:nvSpPr>
        <p:spPr>
          <a:xfrm>
            <a:off x="1355040" y="261288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"/>
          <p:cNvSpPr/>
          <p:nvPr/>
        </p:nvSpPr>
        <p:spPr>
          <a:xfrm>
            <a:off x="1355040" y="219852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"/>
          <p:cNvSpPr/>
          <p:nvPr/>
        </p:nvSpPr>
        <p:spPr>
          <a:xfrm>
            <a:off x="1282680" y="177948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"/>
          <p:cNvSpPr/>
          <p:nvPr/>
        </p:nvSpPr>
        <p:spPr>
          <a:xfrm>
            <a:off x="1273320" y="136836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>
            <a:off x="1474920" y="1279440"/>
            <a:ext cx="4104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"/>
          <p:cNvSpPr/>
          <p:nvPr/>
        </p:nvSpPr>
        <p:spPr>
          <a:xfrm>
            <a:off x="1471680" y="660240"/>
            <a:ext cx="4104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>
            <a:off x="1213920" y="1144440"/>
            <a:ext cx="256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>
            <a:off x="1202760" y="522360"/>
            <a:ext cx="256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"/>
          <p:cNvSpPr/>
          <p:nvPr/>
        </p:nvSpPr>
        <p:spPr>
          <a:xfrm flipV="1">
            <a:off x="1467000" y="1405080"/>
            <a:ext cx="91800" cy="41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"/>
          <p:cNvSpPr/>
          <p:nvPr/>
        </p:nvSpPr>
        <p:spPr>
          <a:xfrm flipV="1">
            <a:off x="1479960" y="1416600"/>
            <a:ext cx="90000" cy="417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5040" bIns="-5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"/>
          <p:cNvSpPr/>
          <p:nvPr/>
        </p:nvSpPr>
        <p:spPr>
          <a:xfrm>
            <a:off x="1591920" y="230652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2.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"/>
          <p:cNvSpPr/>
          <p:nvPr/>
        </p:nvSpPr>
        <p:spPr>
          <a:xfrm>
            <a:off x="1773000" y="703440"/>
            <a:ext cx="390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3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"/>
          <p:cNvSpPr/>
          <p:nvPr/>
        </p:nvSpPr>
        <p:spPr>
          <a:xfrm>
            <a:off x="2014200" y="723960"/>
            <a:ext cx="390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3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"/>
          <p:cNvSpPr/>
          <p:nvPr/>
        </p:nvSpPr>
        <p:spPr>
          <a:xfrm>
            <a:off x="2257200" y="148284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"/>
          <p:cNvSpPr/>
          <p:nvPr/>
        </p:nvSpPr>
        <p:spPr>
          <a:xfrm>
            <a:off x="2624040" y="225900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"/>
          <p:cNvSpPr/>
          <p:nvPr/>
        </p:nvSpPr>
        <p:spPr>
          <a:xfrm>
            <a:off x="2782440" y="213372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4.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"/>
          <p:cNvSpPr/>
          <p:nvPr/>
        </p:nvSpPr>
        <p:spPr>
          <a:xfrm>
            <a:off x="3027240" y="223200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"/>
          <p:cNvSpPr/>
          <p:nvPr/>
        </p:nvSpPr>
        <p:spPr>
          <a:xfrm>
            <a:off x="3176280" y="218124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3.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"/>
          <p:cNvSpPr/>
          <p:nvPr/>
        </p:nvSpPr>
        <p:spPr>
          <a:xfrm>
            <a:off x="3490560" y="237636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.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>
            <a:off x="3747960" y="241632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"/>
          <p:cNvSpPr/>
          <p:nvPr/>
        </p:nvSpPr>
        <p:spPr>
          <a:xfrm>
            <a:off x="3903480" y="217188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4.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"/>
          <p:cNvSpPr/>
          <p:nvPr/>
        </p:nvSpPr>
        <p:spPr>
          <a:xfrm>
            <a:off x="4101840" y="239076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.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"/>
          <p:cNvSpPr/>
          <p:nvPr/>
        </p:nvSpPr>
        <p:spPr>
          <a:xfrm>
            <a:off x="2135160" y="965160"/>
            <a:ext cx="154080" cy="1776600"/>
          </a:xfrm>
          <a:prstGeom prst="rect">
            <a:avLst/>
          </a:prstGeom>
          <a:gradFill rotWithShape="0">
            <a:gsLst>
              <a:gs pos="0">
                <a:srgbClr val="818181"/>
              </a:gs>
              <a:gs pos="100000">
                <a:srgbClr val="b2b2b2">
                  <a:alpha val="49019"/>
                </a:srgbClr>
              </a:gs>
            </a:gsLst>
            <a:lin ang="135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95" name=""/>
          <p:cNvGrpSpPr/>
          <p:nvPr/>
        </p:nvGrpSpPr>
        <p:grpSpPr>
          <a:xfrm>
            <a:off x="3325680" y="2425680"/>
            <a:ext cx="69840" cy="9720"/>
            <a:chOff x="3325680" y="2425680"/>
            <a:chExt cx="69840" cy="9720"/>
          </a:xfrm>
        </p:grpSpPr>
        <p:sp>
          <p:nvSpPr>
            <p:cNvPr id="196" name=""/>
            <p:cNvSpPr/>
            <p:nvPr/>
          </p:nvSpPr>
          <p:spPr>
            <a:xfrm>
              <a:off x="3356640" y="2425680"/>
              <a:ext cx="0" cy="97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080" bIns="-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"/>
            <p:cNvSpPr/>
            <p:nvPr/>
          </p:nvSpPr>
          <p:spPr>
            <a:xfrm>
              <a:off x="3325680" y="2425680"/>
              <a:ext cx="6984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98" name=""/>
          <p:cNvSpPr/>
          <p:nvPr/>
        </p:nvSpPr>
        <p:spPr>
          <a:xfrm flipV="1">
            <a:off x="1895400" y="1337760"/>
            <a:ext cx="231840" cy="1256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"/>
          <p:cNvSpPr/>
          <p:nvPr/>
        </p:nvSpPr>
        <p:spPr>
          <a:xfrm flipV="1">
            <a:off x="2104920" y="1297080"/>
            <a:ext cx="231840" cy="125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"/>
          <p:cNvSpPr/>
          <p:nvPr/>
        </p:nvSpPr>
        <p:spPr>
          <a:xfrm flipV="1">
            <a:off x="2114640" y="1312560"/>
            <a:ext cx="231840" cy="1270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"/>
          <p:cNvSpPr/>
          <p:nvPr/>
        </p:nvSpPr>
        <p:spPr>
          <a:xfrm>
            <a:off x="1774800" y="603360"/>
            <a:ext cx="0" cy="15825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"/>
          <p:cNvSpPr/>
          <p:nvPr/>
        </p:nvSpPr>
        <p:spPr>
          <a:xfrm>
            <a:off x="1774800" y="603360"/>
            <a:ext cx="6476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"/>
          <p:cNvSpPr/>
          <p:nvPr/>
        </p:nvSpPr>
        <p:spPr>
          <a:xfrm>
            <a:off x="1990800" y="596880"/>
            <a:ext cx="0" cy="1429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"/>
          <p:cNvSpPr/>
          <p:nvPr/>
        </p:nvSpPr>
        <p:spPr>
          <a:xfrm>
            <a:off x="2206800" y="596880"/>
            <a:ext cx="0" cy="1429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"/>
          <p:cNvSpPr/>
          <p:nvPr/>
        </p:nvSpPr>
        <p:spPr>
          <a:xfrm>
            <a:off x="2416320" y="596880"/>
            <a:ext cx="0" cy="8110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"/>
          <p:cNvSpPr/>
          <p:nvPr/>
        </p:nvSpPr>
        <p:spPr>
          <a:xfrm>
            <a:off x="1725840" y="385920"/>
            <a:ext cx="25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"/>
          <p:cNvSpPr/>
          <p:nvPr/>
        </p:nvSpPr>
        <p:spPr>
          <a:xfrm>
            <a:off x="1965600" y="385920"/>
            <a:ext cx="25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"/>
          <p:cNvSpPr/>
          <p:nvPr/>
        </p:nvSpPr>
        <p:spPr>
          <a:xfrm>
            <a:off x="2187720" y="392040"/>
            <a:ext cx="25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"/>
          <p:cNvSpPr/>
          <p:nvPr/>
        </p:nvSpPr>
        <p:spPr>
          <a:xfrm>
            <a:off x="3692520" y="1969920"/>
            <a:ext cx="0" cy="406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"/>
          <p:cNvSpPr/>
          <p:nvPr/>
        </p:nvSpPr>
        <p:spPr>
          <a:xfrm>
            <a:off x="3686040" y="1969920"/>
            <a:ext cx="4064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"/>
          <p:cNvSpPr/>
          <p:nvPr/>
        </p:nvSpPr>
        <p:spPr>
          <a:xfrm>
            <a:off x="4086360" y="1963800"/>
            <a:ext cx="0" cy="1890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"/>
          <p:cNvSpPr/>
          <p:nvPr/>
        </p:nvSpPr>
        <p:spPr>
          <a:xfrm>
            <a:off x="3721320" y="1744560"/>
            <a:ext cx="339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"/>
          <p:cNvSpPr/>
          <p:nvPr/>
        </p:nvSpPr>
        <p:spPr>
          <a:xfrm>
            <a:off x="1708200" y="2546280"/>
            <a:ext cx="154080" cy="200160"/>
          </a:xfrm>
          <a:prstGeom prst="rect">
            <a:avLst/>
          </a:prstGeom>
          <a:gradFill rotWithShape="0">
            <a:gsLst>
              <a:gs pos="0">
                <a:srgbClr val="818181"/>
              </a:gs>
              <a:gs pos="100000">
                <a:srgbClr val="b2b2b2">
                  <a:alpha val="49019"/>
                </a:srgbClr>
              </a:gs>
            </a:gsLst>
            <a:lin ang="135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"/>
          <p:cNvSpPr/>
          <p:nvPr/>
        </p:nvSpPr>
        <p:spPr>
          <a:xfrm>
            <a:off x="2499480" y="3198960"/>
            <a:ext cx="1041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  10 25 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15" name=""/>
          <p:cNvGrpSpPr/>
          <p:nvPr/>
        </p:nvGrpSpPr>
        <p:grpSpPr>
          <a:xfrm>
            <a:off x="6710400" y="4678200"/>
            <a:ext cx="69840" cy="69840"/>
            <a:chOff x="6710400" y="4678200"/>
            <a:chExt cx="69840" cy="69840"/>
          </a:xfrm>
        </p:grpSpPr>
        <p:sp>
          <p:nvSpPr>
            <p:cNvPr id="216" name=""/>
            <p:cNvSpPr/>
            <p:nvPr/>
          </p:nvSpPr>
          <p:spPr>
            <a:xfrm>
              <a:off x="6741360" y="4678200"/>
              <a:ext cx="0" cy="69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"/>
            <p:cNvSpPr/>
            <p:nvPr/>
          </p:nvSpPr>
          <p:spPr>
            <a:xfrm>
              <a:off x="6710400" y="4678200"/>
              <a:ext cx="6984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18" name=""/>
          <p:cNvGrpSpPr/>
          <p:nvPr/>
        </p:nvGrpSpPr>
        <p:grpSpPr>
          <a:xfrm>
            <a:off x="7245360" y="5133960"/>
            <a:ext cx="69840" cy="69840"/>
            <a:chOff x="7245360" y="5133960"/>
            <a:chExt cx="69840" cy="69840"/>
          </a:xfrm>
        </p:grpSpPr>
        <p:sp>
          <p:nvSpPr>
            <p:cNvPr id="219" name=""/>
            <p:cNvSpPr/>
            <p:nvPr/>
          </p:nvSpPr>
          <p:spPr>
            <a:xfrm>
              <a:off x="7276320" y="5133960"/>
              <a:ext cx="0" cy="69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"/>
            <p:cNvSpPr/>
            <p:nvPr/>
          </p:nvSpPr>
          <p:spPr>
            <a:xfrm>
              <a:off x="7245360" y="5133960"/>
              <a:ext cx="6984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21" name=""/>
          <p:cNvGrpSpPr/>
          <p:nvPr/>
        </p:nvGrpSpPr>
        <p:grpSpPr>
          <a:xfrm>
            <a:off x="6513480" y="5165640"/>
            <a:ext cx="69840" cy="69840"/>
            <a:chOff x="6513480" y="5165640"/>
            <a:chExt cx="69840" cy="69840"/>
          </a:xfrm>
        </p:grpSpPr>
        <p:sp>
          <p:nvSpPr>
            <p:cNvPr id="222" name=""/>
            <p:cNvSpPr/>
            <p:nvPr/>
          </p:nvSpPr>
          <p:spPr>
            <a:xfrm>
              <a:off x="6544440" y="5165640"/>
              <a:ext cx="0" cy="69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"/>
            <p:cNvSpPr/>
            <p:nvPr/>
          </p:nvSpPr>
          <p:spPr>
            <a:xfrm>
              <a:off x="6513480" y="5165640"/>
              <a:ext cx="6984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24" name=""/>
          <p:cNvGrpSpPr/>
          <p:nvPr/>
        </p:nvGrpSpPr>
        <p:grpSpPr>
          <a:xfrm>
            <a:off x="5756400" y="5099040"/>
            <a:ext cx="69840" cy="69840"/>
            <a:chOff x="5756400" y="5099040"/>
            <a:chExt cx="69840" cy="69840"/>
          </a:xfrm>
        </p:grpSpPr>
        <p:sp>
          <p:nvSpPr>
            <p:cNvPr id="225" name=""/>
            <p:cNvSpPr/>
            <p:nvPr/>
          </p:nvSpPr>
          <p:spPr>
            <a:xfrm>
              <a:off x="5787360" y="5099040"/>
              <a:ext cx="0" cy="69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"/>
            <p:cNvSpPr/>
            <p:nvPr/>
          </p:nvSpPr>
          <p:spPr>
            <a:xfrm>
              <a:off x="5756400" y="5099040"/>
              <a:ext cx="6984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27" name=""/>
          <p:cNvGrpSpPr/>
          <p:nvPr/>
        </p:nvGrpSpPr>
        <p:grpSpPr>
          <a:xfrm>
            <a:off x="5560920" y="5064120"/>
            <a:ext cx="69840" cy="69840"/>
            <a:chOff x="5560920" y="5064120"/>
            <a:chExt cx="69840" cy="69840"/>
          </a:xfrm>
        </p:grpSpPr>
        <p:sp>
          <p:nvSpPr>
            <p:cNvPr id="228" name=""/>
            <p:cNvSpPr/>
            <p:nvPr/>
          </p:nvSpPr>
          <p:spPr>
            <a:xfrm>
              <a:off x="5591880" y="5064120"/>
              <a:ext cx="0" cy="69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"/>
            <p:cNvSpPr/>
            <p:nvPr/>
          </p:nvSpPr>
          <p:spPr>
            <a:xfrm>
              <a:off x="5560920" y="5064120"/>
              <a:ext cx="6984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30" name=""/>
          <p:cNvGrpSpPr/>
          <p:nvPr/>
        </p:nvGrpSpPr>
        <p:grpSpPr>
          <a:xfrm>
            <a:off x="5346720" y="5040360"/>
            <a:ext cx="69840" cy="69840"/>
            <a:chOff x="5346720" y="5040360"/>
            <a:chExt cx="69840" cy="69840"/>
          </a:xfrm>
        </p:grpSpPr>
        <p:sp>
          <p:nvSpPr>
            <p:cNvPr id="231" name=""/>
            <p:cNvSpPr/>
            <p:nvPr/>
          </p:nvSpPr>
          <p:spPr>
            <a:xfrm>
              <a:off x="5377680" y="5040360"/>
              <a:ext cx="0" cy="69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"/>
            <p:cNvSpPr/>
            <p:nvPr/>
          </p:nvSpPr>
          <p:spPr>
            <a:xfrm>
              <a:off x="5346720" y="5040360"/>
              <a:ext cx="6984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33" name=""/>
          <p:cNvSpPr/>
          <p:nvPr/>
        </p:nvSpPr>
        <p:spPr>
          <a:xfrm>
            <a:off x="4611600" y="4756320"/>
            <a:ext cx="3808440" cy="1440"/>
          </a:xfrm>
          <a:prstGeom prst="line">
            <a:avLst/>
          </a:prstGeom>
          <a:ln w="0">
            <a:solidFill>
              <a:srgbClr val="ffffff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"/>
          <p:cNvSpPr/>
          <p:nvPr/>
        </p:nvSpPr>
        <p:spPr>
          <a:xfrm>
            <a:off x="5310360" y="5062680"/>
            <a:ext cx="147600" cy="257040"/>
          </a:xfrm>
          <a:prstGeom prst="rect">
            <a:avLst/>
          </a:prstGeom>
          <a:solidFill>
            <a:srgbClr val="ffff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"/>
          <p:cNvSpPr/>
          <p:nvPr/>
        </p:nvSpPr>
        <p:spPr>
          <a:xfrm>
            <a:off x="5519880" y="5087880"/>
            <a:ext cx="147600" cy="228600"/>
          </a:xfrm>
          <a:prstGeom prst="rect">
            <a:avLst/>
          </a:prstGeom>
          <a:solidFill>
            <a:srgbClr val="ffff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"/>
          <p:cNvSpPr/>
          <p:nvPr/>
        </p:nvSpPr>
        <p:spPr>
          <a:xfrm>
            <a:off x="5715000" y="5126040"/>
            <a:ext cx="147600" cy="190440"/>
          </a:xfrm>
          <a:prstGeom prst="rect">
            <a:avLst/>
          </a:prstGeom>
          <a:solidFill>
            <a:srgbClr val="ffff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"/>
          <p:cNvSpPr/>
          <p:nvPr/>
        </p:nvSpPr>
        <p:spPr>
          <a:xfrm>
            <a:off x="6275520" y="5230800"/>
            <a:ext cx="147600" cy="85680"/>
          </a:xfrm>
          <a:prstGeom prst="rect">
            <a:avLst/>
          </a:prstGeom>
          <a:solidFill>
            <a:srgbClr val="ffff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"/>
          <p:cNvSpPr/>
          <p:nvPr/>
        </p:nvSpPr>
        <p:spPr>
          <a:xfrm>
            <a:off x="6475320" y="5173560"/>
            <a:ext cx="147600" cy="142920"/>
          </a:xfrm>
          <a:prstGeom prst="rect">
            <a:avLst/>
          </a:prstGeom>
          <a:solidFill>
            <a:srgbClr val="ffff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"/>
          <p:cNvSpPr/>
          <p:nvPr/>
        </p:nvSpPr>
        <p:spPr>
          <a:xfrm>
            <a:off x="6662880" y="4697280"/>
            <a:ext cx="147600" cy="619200"/>
          </a:xfrm>
          <a:prstGeom prst="rect">
            <a:avLst/>
          </a:prstGeom>
          <a:solidFill>
            <a:srgbClr val="ffff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"/>
          <p:cNvSpPr/>
          <p:nvPr/>
        </p:nvSpPr>
        <p:spPr>
          <a:xfrm>
            <a:off x="7205760" y="5149800"/>
            <a:ext cx="149040" cy="171360"/>
          </a:xfrm>
          <a:prstGeom prst="rect">
            <a:avLst/>
          </a:prstGeom>
          <a:solidFill>
            <a:srgbClr val="ffff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"/>
          <p:cNvSpPr/>
          <p:nvPr/>
        </p:nvSpPr>
        <p:spPr>
          <a:xfrm>
            <a:off x="5159520" y="4035600"/>
            <a:ext cx="1440" cy="12855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"/>
          <p:cNvSpPr/>
          <p:nvPr/>
        </p:nvSpPr>
        <p:spPr>
          <a:xfrm>
            <a:off x="5130720" y="4888080"/>
            <a:ext cx="3348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"/>
          <p:cNvSpPr/>
          <p:nvPr/>
        </p:nvSpPr>
        <p:spPr>
          <a:xfrm>
            <a:off x="5130720" y="4459320"/>
            <a:ext cx="3348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"/>
          <p:cNvSpPr/>
          <p:nvPr/>
        </p:nvSpPr>
        <p:spPr>
          <a:xfrm>
            <a:off x="5127480" y="4033800"/>
            <a:ext cx="3348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"/>
          <p:cNvSpPr/>
          <p:nvPr/>
        </p:nvSpPr>
        <p:spPr>
          <a:xfrm>
            <a:off x="5004720" y="518796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"/>
          <p:cNvSpPr/>
          <p:nvPr/>
        </p:nvSpPr>
        <p:spPr>
          <a:xfrm>
            <a:off x="5004720" y="475920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"/>
          <p:cNvSpPr/>
          <p:nvPr/>
        </p:nvSpPr>
        <p:spPr>
          <a:xfrm>
            <a:off x="4948560" y="433080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"/>
          <p:cNvSpPr/>
          <p:nvPr/>
        </p:nvSpPr>
        <p:spPr>
          <a:xfrm>
            <a:off x="4948560" y="390204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"/>
          <p:cNvSpPr/>
          <p:nvPr/>
        </p:nvSpPr>
        <p:spPr>
          <a:xfrm>
            <a:off x="5135400" y="5316480"/>
            <a:ext cx="286092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"/>
          <p:cNvSpPr/>
          <p:nvPr/>
        </p:nvSpPr>
        <p:spPr>
          <a:xfrm>
            <a:off x="5552640" y="5373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"/>
          <p:cNvSpPr/>
          <p:nvPr/>
        </p:nvSpPr>
        <p:spPr>
          <a:xfrm>
            <a:off x="6478200" y="537048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"/>
          <p:cNvSpPr/>
          <p:nvPr/>
        </p:nvSpPr>
        <p:spPr>
          <a:xfrm>
            <a:off x="7492320" y="537048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"/>
          <p:cNvSpPr/>
          <p:nvPr/>
        </p:nvSpPr>
        <p:spPr>
          <a:xfrm>
            <a:off x="5259240" y="481500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"/>
          <p:cNvSpPr/>
          <p:nvPr/>
        </p:nvSpPr>
        <p:spPr>
          <a:xfrm>
            <a:off x="5418000" y="484992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2.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"/>
          <p:cNvSpPr/>
          <p:nvPr/>
        </p:nvSpPr>
        <p:spPr>
          <a:xfrm>
            <a:off x="5616360" y="488808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2.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"/>
          <p:cNvSpPr/>
          <p:nvPr/>
        </p:nvSpPr>
        <p:spPr>
          <a:xfrm>
            <a:off x="6205320" y="500076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"/>
          <p:cNvSpPr/>
          <p:nvPr/>
        </p:nvSpPr>
        <p:spPr>
          <a:xfrm>
            <a:off x="6364080" y="494496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.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"/>
          <p:cNvSpPr/>
          <p:nvPr/>
        </p:nvSpPr>
        <p:spPr>
          <a:xfrm>
            <a:off x="6561000" y="444168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7.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"/>
          <p:cNvSpPr/>
          <p:nvPr/>
        </p:nvSpPr>
        <p:spPr>
          <a:xfrm>
            <a:off x="7151400" y="491652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"/>
          <p:cNvSpPr/>
          <p:nvPr/>
        </p:nvSpPr>
        <p:spPr>
          <a:xfrm>
            <a:off x="6338880" y="4338720"/>
            <a:ext cx="0" cy="6476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"/>
          <p:cNvSpPr/>
          <p:nvPr/>
        </p:nvSpPr>
        <p:spPr>
          <a:xfrm>
            <a:off x="6335640" y="4343400"/>
            <a:ext cx="3952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"/>
          <p:cNvSpPr/>
          <p:nvPr/>
        </p:nvSpPr>
        <p:spPr>
          <a:xfrm>
            <a:off x="6730920" y="4340160"/>
            <a:ext cx="0" cy="1080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"/>
          <p:cNvSpPr/>
          <p:nvPr/>
        </p:nvSpPr>
        <p:spPr>
          <a:xfrm>
            <a:off x="6532560" y="4344840"/>
            <a:ext cx="0" cy="576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"/>
          <p:cNvSpPr/>
          <p:nvPr/>
        </p:nvSpPr>
        <p:spPr>
          <a:xfrm>
            <a:off x="6304320" y="4143240"/>
            <a:ext cx="25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"/>
          <p:cNvSpPr/>
          <p:nvPr/>
        </p:nvSpPr>
        <p:spPr>
          <a:xfrm>
            <a:off x="6504120" y="4146480"/>
            <a:ext cx="25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"/>
          <p:cNvSpPr/>
          <p:nvPr/>
        </p:nvSpPr>
        <p:spPr>
          <a:xfrm>
            <a:off x="6846840" y="5303880"/>
            <a:ext cx="147600" cy="14400"/>
          </a:xfrm>
          <a:prstGeom prst="rect">
            <a:avLst/>
          </a:prstGeom>
          <a:solidFill>
            <a:srgbClr val="ffff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2400" bIns="-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"/>
          <p:cNvSpPr/>
          <p:nvPr/>
        </p:nvSpPr>
        <p:spPr>
          <a:xfrm>
            <a:off x="6337800" y="3747960"/>
            <a:ext cx="416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U2O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"/>
          <p:cNvSpPr/>
          <p:nvPr/>
        </p:nvSpPr>
        <p:spPr>
          <a:xfrm>
            <a:off x="5908680" y="5302080"/>
            <a:ext cx="147600" cy="14400"/>
          </a:xfrm>
          <a:prstGeom prst="rect">
            <a:avLst/>
          </a:prstGeom>
          <a:solidFill>
            <a:srgbClr val="ffff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2400" bIns="-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"/>
          <p:cNvSpPr/>
          <p:nvPr/>
        </p:nvSpPr>
        <p:spPr>
          <a:xfrm>
            <a:off x="7419960" y="5302080"/>
            <a:ext cx="147600" cy="14400"/>
          </a:xfrm>
          <a:prstGeom prst="rect">
            <a:avLst/>
          </a:prstGeom>
          <a:solidFill>
            <a:srgbClr val="ffff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2400" bIns="-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"/>
          <p:cNvSpPr/>
          <p:nvPr/>
        </p:nvSpPr>
        <p:spPr>
          <a:xfrm>
            <a:off x="7621560" y="5302080"/>
            <a:ext cx="147600" cy="14400"/>
          </a:xfrm>
          <a:prstGeom prst="rect">
            <a:avLst/>
          </a:prstGeom>
          <a:solidFill>
            <a:srgbClr val="ffff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2400" bIns="-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71" name=""/>
          <p:cNvGrpSpPr/>
          <p:nvPr/>
        </p:nvGrpSpPr>
        <p:grpSpPr>
          <a:xfrm>
            <a:off x="5115960" y="5692680"/>
            <a:ext cx="1154160" cy="276480"/>
            <a:chOff x="5115960" y="5692680"/>
            <a:chExt cx="1154160" cy="276480"/>
          </a:xfrm>
        </p:grpSpPr>
        <p:sp>
          <p:nvSpPr>
            <p:cNvPr id="272" name=""/>
            <p:cNvSpPr/>
            <p:nvPr/>
          </p:nvSpPr>
          <p:spPr>
            <a:xfrm>
              <a:off x="5115960" y="5692680"/>
              <a:ext cx="615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  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-  1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"/>
            <p:cNvSpPr/>
            <p:nvPr/>
          </p:nvSpPr>
          <p:spPr>
            <a:xfrm>
              <a:off x="5600520" y="5692680"/>
              <a:ext cx="451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2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"/>
            <p:cNvSpPr/>
            <p:nvPr/>
          </p:nvSpPr>
          <p:spPr>
            <a:xfrm>
              <a:off x="5817960" y="5692680"/>
              <a:ext cx="452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75" name=""/>
          <p:cNvGrpSpPr/>
          <p:nvPr/>
        </p:nvGrpSpPr>
        <p:grpSpPr>
          <a:xfrm>
            <a:off x="6102000" y="5692680"/>
            <a:ext cx="1154160" cy="276480"/>
            <a:chOff x="6102000" y="5692680"/>
            <a:chExt cx="1154160" cy="276480"/>
          </a:xfrm>
        </p:grpSpPr>
        <p:sp>
          <p:nvSpPr>
            <p:cNvPr id="276" name=""/>
            <p:cNvSpPr/>
            <p:nvPr/>
          </p:nvSpPr>
          <p:spPr>
            <a:xfrm>
              <a:off x="6102000" y="5692680"/>
              <a:ext cx="615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  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-  1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"/>
            <p:cNvSpPr/>
            <p:nvPr/>
          </p:nvSpPr>
          <p:spPr>
            <a:xfrm>
              <a:off x="6586560" y="5692680"/>
              <a:ext cx="451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2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"/>
            <p:cNvSpPr/>
            <p:nvPr/>
          </p:nvSpPr>
          <p:spPr>
            <a:xfrm>
              <a:off x="6804000" y="5692680"/>
              <a:ext cx="452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79" name=""/>
          <p:cNvGrpSpPr/>
          <p:nvPr/>
        </p:nvGrpSpPr>
        <p:grpSpPr>
          <a:xfrm>
            <a:off x="7027200" y="5692680"/>
            <a:ext cx="1154880" cy="276480"/>
            <a:chOff x="7027200" y="5692680"/>
            <a:chExt cx="1154880" cy="276480"/>
          </a:xfrm>
        </p:grpSpPr>
        <p:sp>
          <p:nvSpPr>
            <p:cNvPr id="280" name=""/>
            <p:cNvSpPr/>
            <p:nvPr/>
          </p:nvSpPr>
          <p:spPr>
            <a:xfrm>
              <a:off x="7027200" y="5692680"/>
              <a:ext cx="615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  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-  1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"/>
            <p:cNvSpPr/>
            <p:nvPr/>
          </p:nvSpPr>
          <p:spPr>
            <a:xfrm>
              <a:off x="7512120" y="5692680"/>
              <a:ext cx="452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2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"/>
            <p:cNvSpPr/>
            <p:nvPr/>
          </p:nvSpPr>
          <p:spPr>
            <a:xfrm>
              <a:off x="7729560" y="5692680"/>
              <a:ext cx="452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83" name=""/>
          <p:cNvSpPr/>
          <p:nvPr/>
        </p:nvSpPr>
        <p:spPr>
          <a:xfrm>
            <a:off x="5519160" y="282096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"/>
          <p:cNvSpPr/>
          <p:nvPr/>
        </p:nvSpPr>
        <p:spPr>
          <a:xfrm>
            <a:off x="6482880" y="2817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"/>
          <p:cNvSpPr/>
          <p:nvPr/>
        </p:nvSpPr>
        <p:spPr>
          <a:xfrm>
            <a:off x="7363800" y="28177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86" name=""/>
          <p:cNvGrpSpPr/>
          <p:nvPr/>
        </p:nvGrpSpPr>
        <p:grpSpPr>
          <a:xfrm>
            <a:off x="7404120" y="2610000"/>
            <a:ext cx="71280" cy="69840"/>
            <a:chOff x="7404120" y="2610000"/>
            <a:chExt cx="71280" cy="69840"/>
          </a:xfrm>
        </p:grpSpPr>
        <p:sp>
          <p:nvSpPr>
            <p:cNvPr id="287" name=""/>
            <p:cNvSpPr/>
            <p:nvPr/>
          </p:nvSpPr>
          <p:spPr>
            <a:xfrm>
              <a:off x="7435800" y="2610000"/>
              <a:ext cx="0" cy="69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"/>
            <p:cNvSpPr/>
            <p:nvPr/>
          </p:nvSpPr>
          <p:spPr>
            <a:xfrm>
              <a:off x="7404120" y="2610000"/>
              <a:ext cx="712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89" name=""/>
          <p:cNvGrpSpPr/>
          <p:nvPr/>
        </p:nvGrpSpPr>
        <p:grpSpPr>
          <a:xfrm>
            <a:off x="7211880" y="1789200"/>
            <a:ext cx="71280" cy="69840"/>
            <a:chOff x="7211880" y="1789200"/>
            <a:chExt cx="71280" cy="69840"/>
          </a:xfrm>
        </p:grpSpPr>
        <p:sp>
          <p:nvSpPr>
            <p:cNvPr id="290" name=""/>
            <p:cNvSpPr/>
            <p:nvPr/>
          </p:nvSpPr>
          <p:spPr>
            <a:xfrm>
              <a:off x="7243560" y="1789200"/>
              <a:ext cx="0" cy="69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"/>
            <p:cNvSpPr/>
            <p:nvPr/>
          </p:nvSpPr>
          <p:spPr>
            <a:xfrm>
              <a:off x="7211880" y="1789200"/>
              <a:ext cx="712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92" name=""/>
          <p:cNvGrpSpPr/>
          <p:nvPr/>
        </p:nvGrpSpPr>
        <p:grpSpPr>
          <a:xfrm>
            <a:off x="6702480" y="1069920"/>
            <a:ext cx="71280" cy="69840"/>
            <a:chOff x="6702480" y="1069920"/>
            <a:chExt cx="71280" cy="69840"/>
          </a:xfrm>
        </p:grpSpPr>
        <p:sp>
          <p:nvSpPr>
            <p:cNvPr id="293" name=""/>
            <p:cNvSpPr/>
            <p:nvPr/>
          </p:nvSpPr>
          <p:spPr>
            <a:xfrm>
              <a:off x="6734160" y="1069920"/>
              <a:ext cx="0" cy="69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"/>
            <p:cNvSpPr/>
            <p:nvPr/>
          </p:nvSpPr>
          <p:spPr>
            <a:xfrm>
              <a:off x="6702480" y="1069920"/>
              <a:ext cx="712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95" name=""/>
          <p:cNvGrpSpPr/>
          <p:nvPr/>
        </p:nvGrpSpPr>
        <p:grpSpPr>
          <a:xfrm>
            <a:off x="5357880" y="2549520"/>
            <a:ext cx="71280" cy="69840"/>
            <a:chOff x="5357880" y="2549520"/>
            <a:chExt cx="71280" cy="69840"/>
          </a:xfrm>
        </p:grpSpPr>
        <p:sp>
          <p:nvSpPr>
            <p:cNvPr id="296" name=""/>
            <p:cNvSpPr/>
            <p:nvPr/>
          </p:nvSpPr>
          <p:spPr>
            <a:xfrm>
              <a:off x="5389560" y="2549520"/>
              <a:ext cx="0" cy="69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"/>
            <p:cNvSpPr/>
            <p:nvPr/>
          </p:nvSpPr>
          <p:spPr>
            <a:xfrm>
              <a:off x="5357880" y="2549520"/>
              <a:ext cx="712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98" name=""/>
          <p:cNvGrpSpPr/>
          <p:nvPr/>
        </p:nvGrpSpPr>
        <p:grpSpPr>
          <a:xfrm>
            <a:off x="5549760" y="2549520"/>
            <a:ext cx="71280" cy="69840"/>
            <a:chOff x="5549760" y="2549520"/>
            <a:chExt cx="71280" cy="69840"/>
          </a:xfrm>
        </p:grpSpPr>
        <p:sp>
          <p:nvSpPr>
            <p:cNvPr id="299" name=""/>
            <p:cNvSpPr/>
            <p:nvPr/>
          </p:nvSpPr>
          <p:spPr>
            <a:xfrm>
              <a:off x="5581440" y="2549520"/>
              <a:ext cx="0" cy="69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"/>
            <p:cNvSpPr/>
            <p:nvPr/>
          </p:nvSpPr>
          <p:spPr>
            <a:xfrm>
              <a:off x="5549760" y="2549520"/>
              <a:ext cx="712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01" name=""/>
          <p:cNvGrpSpPr/>
          <p:nvPr/>
        </p:nvGrpSpPr>
        <p:grpSpPr>
          <a:xfrm>
            <a:off x="6329520" y="2349360"/>
            <a:ext cx="71280" cy="69840"/>
            <a:chOff x="6329520" y="2349360"/>
            <a:chExt cx="71280" cy="69840"/>
          </a:xfrm>
        </p:grpSpPr>
        <p:sp>
          <p:nvSpPr>
            <p:cNvPr id="302" name=""/>
            <p:cNvSpPr/>
            <p:nvPr/>
          </p:nvSpPr>
          <p:spPr>
            <a:xfrm>
              <a:off x="6361200" y="2349360"/>
              <a:ext cx="0" cy="69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"/>
            <p:cNvSpPr/>
            <p:nvPr/>
          </p:nvSpPr>
          <p:spPr>
            <a:xfrm>
              <a:off x="6329520" y="2349360"/>
              <a:ext cx="712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04" name=""/>
          <p:cNvGrpSpPr/>
          <p:nvPr/>
        </p:nvGrpSpPr>
        <p:grpSpPr>
          <a:xfrm>
            <a:off x="6516720" y="2271600"/>
            <a:ext cx="71280" cy="69840"/>
            <a:chOff x="6516720" y="2271600"/>
            <a:chExt cx="71280" cy="69840"/>
          </a:xfrm>
        </p:grpSpPr>
        <p:sp>
          <p:nvSpPr>
            <p:cNvPr id="305" name=""/>
            <p:cNvSpPr/>
            <p:nvPr/>
          </p:nvSpPr>
          <p:spPr>
            <a:xfrm>
              <a:off x="6548400" y="2271600"/>
              <a:ext cx="0" cy="69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"/>
            <p:cNvSpPr/>
            <p:nvPr/>
          </p:nvSpPr>
          <p:spPr>
            <a:xfrm>
              <a:off x="6516720" y="2271600"/>
              <a:ext cx="712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07" name=""/>
          <p:cNvSpPr/>
          <p:nvPr/>
        </p:nvSpPr>
        <p:spPr>
          <a:xfrm>
            <a:off x="5319720" y="2560680"/>
            <a:ext cx="152280" cy="181080"/>
          </a:xfrm>
          <a:prstGeom prst="rect">
            <a:avLst/>
          </a:prstGeom>
          <a:gradFill rotWithShape="0">
            <a:gsLst>
              <a:gs pos="0">
                <a:srgbClr val="131313"/>
              </a:gs>
              <a:gs pos="100000">
                <a:srgbClr val="000000"/>
              </a:gs>
            </a:gsLst>
            <a:lin ang="135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"/>
          <p:cNvSpPr/>
          <p:nvPr/>
        </p:nvSpPr>
        <p:spPr>
          <a:xfrm>
            <a:off x="5505480" y="2560680"/>
            <a:ext cx="154080" cy="181080"/>
          </a:xfrm>
          <a:prstGeom prst="rect">
            <a:avLst/>
          </a:prstGeom>
          <a:gradFill rotWithShape="0">
            <a:gsLst>
              <a:gs pos="0">
                <a:srgbClr val="131313"/>
              </a:gs>
              <a:gs pos="100000">
                <a:srgbClr val="000000"/>
              </a:gs>
            </a:gsLst>
            <a:lin ang="135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"/>
          <p:cNvSpPr/>
          <p:nvPr/>
        </p:nvSpPr>
        <p:spPr>
          <a:xfrm>
            <a:off x="5703840" y="2655720"/>
            <a:ext cx="152280" cy="86040"/>
          </a:xfrm>
          <a:prstGeom prst="rect">
            <a:avLst/>
          </a:prstGeom>
          <a:gradFill rotWithShape="0">
            <a:gsLst>
              <a:gs pos="0">
                <a:srgbClr val="131313"/>
              </a:gs>
              <a:gs pos="100000">
                <a:srgbClr val="000000"/>
              </a:gs>
            </a:gsLst>
            <a:lin ang="135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9240" bIns="39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"/>
          <p:cNvSpPr/>
          <p:nvPr/>
        </p:nvSpPr>
        <p:spPr>
          <a:xfrm>
            <a:off x="6292800" y="2360520"/>
            <a:ext cx="152280" cy="381240"/>
          </a:xfrm>
          <a:prstGeom prst="rect">
            <a:avLst/>
          </a:prstGeom>
          <a:gradFill rotWithShape="0">
            <a:gsLst>
              <a:gs pos="0">
                <a:srgbClr val="131313"/>
              </a:gs>
              <a:gs pos="100000">
                <a:srgbClr val="000000"/>
              </a:gs>
            </a:gsLst>
            <a:lin ang="135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"/>
          <p:cNvSpPr/>
          <p:nvPr/>
        </p:nvSpPr>
        <p:spPr>
          <a:xfrm>
            <a:off x="6478560" y="2292480"/>
            <a:ext cx="154080" cy="453960"/>
          </a:xfrm>
          <a:prstGeom prst="rect">
            <a:avLst/>
          </a:prstGeom>
          <a:gradFill rotWithShape="0">
            <a:gsLst>
              <a:gs pos="0">
                <a:srgbClr val="131313"/>
              </a:gs>
              <a:gs pos="100000">
                <a:srgbClr val="000000"/>
              </a:gs>
            </a:gsLst>
            <a:lin ang="135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"/>
          <p:cNvSpPr/>
          <p:nvPr/>
        </p:nvSpPr>
        <p:spPr>
          <a:xfrm>
            <a:off x="6662880" y="1095480"/>
            <a:ext cx="150840" cy="1646280"/>
          </a:xfrm>
          <a:prstGeom prst="rect">
            <a:avLst/>
          </a:prstGeom>
          <a:gradFill rotWithShape="0">
            <a:gsLst>
              <a:gs pos="0">
                <a:srgbClr val="131313"/>
              </a:gs>
              <a:gs pos="100000">
                <a:srgbClr val="000000"/>
              </a:gs>
            </a:gsLst>
            <a:lin ang="135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"/>
          <p:cNvSpPr/>
          <p:nvPr/>
        </p:nvSpPr>
        <p:spPr>
          <a:xfrm>
            <a:off x="7174080" y="1808280"/>
            <a:ext cx="153720" cy="931680"/>
          </a:xfrm>
          <a:prstGeom prst="rect">
            <a:avLst/>
          </a:prstGeom>
          <a:gradFill rotWithShape="0">
            <a:gsLst>
              <a:gs pos="0">
                <a:srgbClr val="131313"/>
              </a:gs>
              <a:gs pos="100000">
                <a:srgbClr val="000000"/>
              </a:gs>
            </a:gsLst>
            <a:lin ang="135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"/>
          <p:cNvSpPr/>
          <p:nvPr/>
        </p:nvSpPr>
        <p:spPr>
          <a:xfrm>
            <a:off x="7364520" y="2617920"/>
            <a:ext cx="150840" cy="123840"/>
          </a:xfrm>
          <a:prstGeom prst="rect">
            <a:avLst/>
          </a:prstGeom>
          <a:gradFill rotWithShape="0">
            <a:gsLst>
              <a:gs pos="0">
                <a:srgbClr val="131313"/>
              </a:gs>
              <a:gs pos="100000">
                <a:srgbClr val="000000"/>
              </a:gs>
            </a:gsLst>
            <a:lin ang="135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"/>
          <p:cNvSpPr/>
          <p:nvPr/>
        </p:nvSpPr>
        <p:spPr>
          <a:xfrm>
            <a:off x="5097600" y="2746440"/>
            <a:ext cx="287964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"/>
          <p:cNvSpPr/>
          <p:nvPr/>
        </p:nvSpPr>
        <p:spPr>
          <a:xfrm>
            <a:off x="6343920" y="217440"/>
            <a:ext cx="3895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it-IT" sz="1200" spc="-1" strike="noStrike">
                <a:solidFill>
                  <a:srgbClr val="000000"/>
                </a:solidFill>
                <a:latin typeface="Arial"/>
              </a:rPr>
              <a:t>Hobi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"/>
          <p:cNvSpPr/>
          <p:nvPr/>
        </p:nvSpPr>
        <p:spPr>
          <a:xfrm>
            <a:off x="5133960" y="657360"/>
            <a:ext cx="1440" cy="20937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"/>
          <p:cNvSpPr/>
          <p:nvPr/>
        </p:nvSpPr>
        <p:spPr>
          <a:xfrm>
            <a:off x="5083200" y="2355840"/>
            <a:ext cx="507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"/>
          <p:cNvSpPr/>
          <p:nvPr/>
        </p:nvSpPr>
        <p:spPr>
          <a:xfrm>
            <a:off x="5083200" y="1940040"/>
            <a:ext cx="507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"/>
          <p:cNvSpPr/>
          <p:nvPr/>
        </p:nvSpPr>
        <p:spPr>
          <a:xfrm>
            <a:off x="5083200" y="1523880"/>
            <a:ext cx="5076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"/>
          <p:cNvSpPr/>
          <p:nvPr/>
        </p:nvSpPr>
        <p:spPr>
          <a:xfrm>
            <a:off x="4968000" y="259236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"/>
          <p:cNvSpPr/>
          <p:nvPr/>
        </p:nvSpPr>
        <p:spPr>
          <a:xfrm>
            <a:off x="4968000" y="2209680"/>
            <a:ext cx="8604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"/>
          <p:cNvSpPr/>
          <p:nvPr/>
        </p:nvSpPr>
        <p:spPr>
          <a:xfrm>
            <a:off x="4881600" y="179064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"/>
          <p:cNvSpPr/>
          <p:nvPr/>
        </p:nvSpPr>
        <p:spPr>
          <a:xfrm>
            <a:off x="4869000" y="1395360"/>
            <a:ext cx="171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"/>
          <p:cNvSpPr/>
          <p:nvPr/>
        </p:nvSpPr>
        <p:spPr>
          <a:xfrm>
            <a:off x="5086440" y="1305000"/>
            <a:ext cx="507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"/>
          <p:cNvSpPr/>
          <p:nvPr/>
        </p:nvSpPr>
        <p:spPr>
          <a:xfrm>
            <a:off x="5086440" y="662040"/>
            <a:ext cx="5076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"/>
          <p:cNvSpPr/>
          <p:nvPr/>
        </p:nvSpPr>
        <p:spPr>
          <a:xfrm>
            <a:off x="4804920" y="1168560"/>
            <a:ext cx="256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"/>
          <p:cNvSpPr/>
          <p:nvPr/>
        </p:nvSpPr>
        <p:spPr>
          <a:xfrm>
            <a:off x="4811040" y="539640"/>
            <a:ext cx="2566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"/>
          <p:cNvSpPr/>
          <p:nvPr/>
        </p:nvSpPr>
        <p:spPr>
          <a:xfrm flipV="1">
            <a:off x="5083920" y="1427760"/>
            <a:ext cx="109800" cy="370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720" bIns="-9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"/>
          <p:cNvSpPr/>
          <p:nvPr/>
        </p:nvSpPr>
        <p:spPr>
          <a:xfrm flipV="1">
            <a:off x="5093280" y="1444320"/>
            <a:ext cx="108360" cy="37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9360" bIns="-9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"/>
          <p:cNvSpPr/>
          <p:nvPr/>
        </p:nvSpPr>
        <p:spPr>
          <a:xfrm>
            <a:off x="5205240" y="232092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2.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"/>
          <p:cNvSpPr/>
          <p:nvPr/>
        </p:nvSpPr>
        <p:spPr>
          <a:xfrm>
            <a:off x="5400360" y="221616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2.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"/>
          <p:cNvSpPr/>
          <p:nvPr/>
        </p:nvSpPr>
        <p:spPr>
          <a:xfrm>
            <a:off x="5649840" y="239220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"/>
          <p:cNvSpPr/>
          <p:nvPr/>
        </p:nvSpPr>
        <p:spPr>
          <a:xfrm>
            <a:off x="6167160" y="211140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4.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"/>
          <p:cNvSpPr/>
          <p:nvPr/>
        </p:nvSpPr>
        <p:spPr>
          <a:xfrm>
            <a:off x="6356160" y="199872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4.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"/>
          <p:cNvSpPr/>
          <p:nvPr/>
        </p:nvSpPr>
        <p:spPr>
          <a:xfrm>
            <a:off x="6540120" y="858960"/>
            <a:ext cx="390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0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"/>
          <p:cNvSpPr/>
          <p:nvPr/>
        </p:nvSpPr>
        <p:spPr>
          <a:xfrm>
            <a:off x="7086600" y="155736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6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"/>
          <p:cNvSpPr/>
          <p:nvPr/>
        </p:nvSpPr>
        <p:spPr>
          <a:xfrm>
            <a:off x="7252920" y="2359080"/>
            <a:ext cx="356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.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"/>
          <p:cNvSpPr/>
          <p:nvPr/>
        </p:nvSpPr>
        <p:spPr>
          <a:xfrm>
            <a:off x="6342120" y="720720"/>
            <a:ext cx="0" cy="12841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"/>
          <p:cNvSpPr/>
          <p:nvPr/>
        </p:nvSpPr>
        <p:spPr>
          <a:xfrm>
            <a:off x="6345360" y="727200"/>
            <a:ext cx="3952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"/>
          <p:cNvSpPr/>
          <p:nvPr/>
        </p:nvSpPr>
        <p:spPr>
          <a:xfrm>
            <a:off x="6734160" y="725400"/>
            <a:ext cx="0" cy="1447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"/>
          <p:cNvSpPr/>
          <p:nvPr/>
        </p:nvSpPr>
        <p:spPr>
          <a:xfrm>
            <a:off x="6355080" y="511200"/>
            <a:ext cx="339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"/>
          <p:cNvSpPr/>
          <p:nvPr/>
        </p:nvSpPr>
        <p:spPr>
          <a:xfrm>
            <a:off x="5894280" y="2695680"/>
            <a:ext cx="152640" cy="50760"/>
          </a:xfrm>
          <a:prstGeom prst="rect">
            <a:avLst/>
          </a:prstGeom>
          <a:gradFill rotWithShape="0">
            <a:gsLst>
              <a:gs pos="0">
                <a:srgbClr val="131313"/>
              </a:gs>
              <a:gs pos="100000">
                <a:srgbClr val="000000"/>
              </a:gs>
            </a:gsLst>
            <a:lin ang="135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"/>
          <p:cNvSpPr/>
          <p:nvPr/>
        </p:nvSpPr>
        <p:spPr>
          <a:xfrm>
            <a:off x="6858000" y="2728800"/>
            <a:ext cx="152280" cy="14400"/>
          </a:xfrm>
          <a:prstGeom prst="rect">
            <a:avLst/>
          </a:prstGeom>
          <a:gradFill rotWithShape="0">
            <a:gsLst>
              <a:gs pos="0">
                <a:srgbClr val="131313"/>
              </a:gs>
              <a:gs pos="100000">
                <a:srgbClr val="000000"/>
              </a:gs>
            </a:gsLst>
            <a:lin ang="135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2400" bIns="-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"/>
          <p:cNvSpPr/>
          <p:nvPr/>
        </p:nvSpPr>
        <p:spPr>
          <a:xfrm>
            <a:off x="7242120" y="1506600"/>
            <a:ext cx="0" cy="1047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"/>
          <p:cNvSpPr/>
          <p:nvPr/>
        </p:nvSpPr>
        <p:spPr>
          <a:xfrm>
            <a:off x="7238880" y="1511280"/>
            <a:ext cx="2080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"/>
          <p:cNvSpPr/>
          <p:nvPr/>
        </p:nvSpPr>
        <p:spPr>
          <a:xfrm>
            <a:off x="7440480" y="1509840"/>
            <a:ext cx="0" cy="7714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"/>
          <p:cNvSpPr/>
          <p:nvPr/>
        </p:nvSpPr>
        <p:spPr>
          <a:xfrm>
            <a:off x="7197840" y="1308240"/>
            <a:ext cx="259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"/>
          <p:cNvSpPr/>
          <p:nvPr/>
        </p:nvSpPr>
        <p:spPr>
          <a:xfrm>
            <a:off x="7548480" y="2732040"/>
            <a:ext cx="152640" cy="14400"/>
          </a:xfrm>
          <a:prstGeom prst="rect">
            <a:avLst/>
          </a:prstGeom>
          <a:gradFill rotWithShape="0">
            <a:gsLst>
              <a:gs pos="0">
                <a:srgbClr val="131313"/>
              </a:gs>
              <a:gs pos="100000">
                <a:srgbClr val="000000"/>
              </a:gs>
            </a:gsLst>
            <a:lin ang="135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2400" bIns="-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"/>
          <p:cNvSpPr/>
          <p:nvPr/>
        </p:nvSpPr>
        <p:spPr>
          <a:xfrm>
            <a:off x="7745400" y="2732040"/>
            <a:ext cx="152280" cy="14400"/>
          </a:xfrm>
          <a:prstGeom prst="rect">
            <a:avLst/>
          </a:prstGeom>
          <a:gradFill rotWithShape="0">
            <a:gsLst>
              <a:gs pos="0">
                <a:srgbClr val="131313"/>
              </a:gs>
              <a:gs pos="100000">
                <a:srgbClr val="000000"/>
              </a:gs>
            </a:gsLst>
            <a:lin ang="13500000"/>
          </a:gra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2400" bIns="-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"/>
          <p:cNvSpPr/>
          <p:nvPr/>
        </p:nvSpPr>
        <p:spPr>
          <a:xfrm flipV="1">
            <a:off x="6618240" y="1395000"/>
            <a:ext cx="227160" cy="716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"/>
          <p:cNvSpPr/>
          <p:nvPr/>
        </p:nvSpPr>
        <p:spPr>
          <a:xfrm flipV="1">
            <a:off x="6620040" y="1415520"/>
            <a:ext cx="226800" cy="716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840" bIns="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53" name=""/>
          <p:cNvGrpSpPr/>
          <p:nvPr/>
        </p:nvGrpSpPr>
        <p:grpSpPr>
          <a:xfrm>
            <a:off x="5091480" y="3195720"/>
            <a:ext cx="2934360" cy="279360"/>
            <a:chOff x="5091480" y="3195720"/>
            <a:chExt cx="2934360" cy="279360"/>
          </a:xfrm>
        </p:grpSpPr>
        <p:sp>
          <p:nvSpPr>
            <p:cNvPr id="354" name=""/>
            <p:cNvSpPr/>
            <p:nvPr/>
          </p:nvSpPr>
          <p:spPr>
            <a:xfrm>
              <a:off x="5091480" y="3198600"/>
              <a:ext cx="1041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  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-  10 25 5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5" name=""/>
            <p:cNvSpPr/>
            <p:nvPr/>
          </p:nvSpPr>
          <p:spPr>
            <a:xfrm>
              <a:off x="6984000" y="3195720"/>
              <a:ext cx="1041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  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-  10 25 5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6" name=""/>
            <p:cNvSpPr/>
            <p:nvPr/>
          </p:nvSpPr>
          <p:spPr>
            <a:xfrm>
              <a:off x="6045480" y="3198600"/>
              <a:ext cx="1041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   </a:t>
              </a: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-  10 25 5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57" name=""/>
          <p:cNvSpPr/>
          <p:nvPr/>
        </p:nvSpPr>
        <p:spPr>
          <a:xfrm>
            <a:off x="7818480" y="5302080"/>
            <a:ext cx="147600" cy="14400"/>
          </a:xfrm>
          <a:prstGeom prst="rect">
            <a:avLst/>
          </a:prstGeom>
          <a:solidFill>
            <a:srgbClr val="ffffff"/>
          </a:solidFill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2400" bIns="-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2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12-12T09:55:08Z</dcterms:created>
  <dc:creator>Massimo</dc:creator>
  <dc:description/>
  <dc:language>en-US</dc:language>
  <cp:lastModifiedBy>Elena</cp:lastModifiedBy>
  <dcterms:modified xsi:type="dcterms:W3CDTF">2009-08-28T14:42:59Z</dcterms:modified>
  <cp:revision>79</cp:revision>
  <dc:subject/>
  <dc:title>Diapositiva 1</dc:title>
</cp:coreProperties>
</file>